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95" r:id="rId2"/>
    <p:sldId id="296" r:id="rId3"/>
    <p:sldId id="297" r:id="rId4"/>
    <p:sldId id="290" r:id="rId5"/>
  </p:sldIdLst>
  <p:sldSz cx="12192000" cy="6858000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035"/>
  </p:normalViewPr>
  <p:slideViewPr>
    <p:cSldViewPr snapToGrid="0" snapToObjects="1">
      <p:cViewPr>
        <p:scale>
          <a:sx n="100" d="100"/>
          <a:sy n="100" d="100"/>
        </p:scale>
        <p:origin x="-954" y="-4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FFF64D-F6C6-9E4B-B010-B9E6727AE76D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E2B7DD-4ED1-BC4A-83FF-785196C03C8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0688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0A4E39-7089-9346-949C-0134EB34CAAF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4642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99942368-1338-394B-8EA6-CD97C10CBA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xmlns="" id="{1FE8166C-683D-F548-9EEB-83BBFF5330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B7CB7A67-EF64-D044-8C6E-6832FC2B1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62FE2E52-5001-BB4F-8210-4A0F327BD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0C833A7F-1EEA-2646-BC30-B9D3AF48E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7649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579E315B-5469-F047-B30E-77F9A3BA43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xmlns="" id="{2B1427CB-E1FD-7F40-B239-31AC990A28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BED1C8D1-BA58-EE44-B2AF-0ED52F164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D1BF2D9F-BC67-0F4F-86FF-135E782C1D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E19C08AE-19EF-8443-B438-219C77528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8398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xmlns="" id="{FAB7C6B7-5368-8448-808C-1910C05FC0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xmlns="" id="{8134950A-ED17-2A4B-BB1D-D92B417FEB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A61123B1-9117-BE47-825B-A8A94308F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304AB50B-7301-9E41-BC1B-18B778DDA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0C227611-7F09-9245-99FA-A1E7643F2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0402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CF09430D-BCDA-514C-9DD7-FED4E8C53A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E87CD512-23F7-1440-8539-F8F90F3CA7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9175B586-C3B8-EA4F-B712-9C4B19502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D936890D-E24B-A34E-8A10-8927A9FC8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890DD853-312D-9C4C-AF66-D592E1CAC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4403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FE2873D0-8522-2D4A-9B10-8E7D01D70F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73FB161D-B83A-F14A-8D26-5EF7E9940C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5D332319-5A02-D847-8797-B20DC2604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80795045-22F1-8344-8987-C731D8DDB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0897EE5B-BD2B-C046-84E8-3C90E3D18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0038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96D83FE7-228F-1447-AC4F-79E7991F2A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0698EB5C-F95A-2A4A-AC32-00B1CDD930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xmlns="" id="{4CA721E5-DD23-5F4C-BA42-8ECB426BF3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E16EBA24-622D-9A43-B06B-06CF5DA45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0CC9C6FF-9CEF-B245-AA8C-A709CB1BC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C0E14DAD-16BB-D848-A12A-2A2AE46E0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8671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3AE74676-B15F-E94D-A481-8456759FEF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A2052DF9-4F33-7942-A37B-AFFB2FD82B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xmlns="" id="{2CD83C5B-2F18-D94A-B11D-168BEE7131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xmlns="" id="{5927961B-EE69-B84B-BA19-F9173F0F0B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xmlns="" id="{8A00F1EE-BBF3-7948-B81B-E17A87BBCA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xmlns="" id="{68F91C0A-128A-7746-B195-141F2B894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xmlns="" id="{C1EB463A-5C03-2344-80FE-4406B733A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xmlns="" id="{1ACE6F74-90B4-8541-B7B6-961567FCD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0462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E68D2573-1F2E-BA42-ABEC-23701903E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xmlns="" id="{6F5B5ED5-C74A-EA47-A645-D1B0B6EFB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xmlns="" id="{2A5BAA22-74C1-3145-A517-A2974C703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xmlns="" id="{6B7BB463-3320-AE48-9307-F7BFD8760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7335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xmlns="" id="{DE3711D7-D16C-754C-B174-E611C28DE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xmlns="" id="{9C83DC33-1511-2146-8CB7-E9E3E1CB7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xmlns="" id="{7E812600-D52F-F445-84FB-C74168EB5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7968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B79E31E7-DA3E-EE4F-80A4-F979A263BC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65AE42C2-5037-1C47-BFA2-8F702A055D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xmlns="" id="{CB39FF3A-D946-0C4B-8483-FC37FD9628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57107251-6350-B347-AF2B-8314CEE60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7EA77DAF-351B-F845-BCAF-B1A16356D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FBD68AE9-9D15-B941-970C-F5B52ECBD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6314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50AC5136-E340-F44C-B713-B4E298DB37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xmlns="" id="{50074F3C-2ACE-CC4D-971F-29AD8EDB6C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xmlns="" id="{535D6D43-CDEB-5F45-8084-207A741017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1B79B23B-9C6F-884E-8713-4CE71AFF5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EE53B4BF-9AD7-F242-BA0C-DAE3B459C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BF89BB78-14CE-F54D-9C97-65F942F79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485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xmlns="" id="{1377B26E-2E8F-A54D-8E4E-14FEFF59E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A24896FC-0753-BC4B-90FA-1E7D5D11C1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3EC31F2D-7D87-A942-B300-F6B416D075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4AAFF-95AE-834D-9965-33C61370E949}" type="datetimeFigureOut">
              <a:rPr lang="it-IT" smtClean="0"/>
              <a:t>17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1FE5FC4D-1802-694A-AEEB-EBDA898607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547D92F6-9B81-CE40-81A9-B008AD72E0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1945E-8C50-CA49-946D-C14AB533DD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9628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485776" y="962666"/>
            <a:ext cx="10559371" cy="3890925"/>
            <a:chOff x="828676" y="668752"/>
            <a:chExt cx="10559371" cy="3890925"/>
          </a:xfrm>
        </p:grpSpPr>
        <p:sp>
          <p:nvSpPr>
            <p:cNvPr id="10" name="CasellaDiTesto 9"/>
            <p:cNvSpPr txBox="1"/>
            <p:nvPr/>
          </p:nvSpPr>
          <p:spPr>
            <a:xfrm>
              <a:off x="4460782" y="2452803"/>
              <a:ext cx="255661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 smtClean="0"/>
                <a:t>Patients</a:t>
              </a:r>
              <a:r>
                <a:rPr lang="it-IT" sz="1200" dirty="0" smtClean="0"/>
                <a:t> </a:t>
              </a:r>
              <a:r>
                <a:rPr lang="it-IT" sz="1200" dirty="0" err="1"/>
                <a:t>i</a:t>
              </a:r>
              <a:r>
                <a:rPr lang="it-IT" sz="1200" dirty="0" err="1" smtClean="0"/>
                <a:t>ncluded</a:t>
              </a:r>
              <a:r>
                <a:rPr lang="it-IT" sz="1200" dirty="0" smtClean="0"/>
                <a:t> for data </a:t>
              </a:r>
              <a:r>
                <a:rPr lang="it-IT" sz="1200" dirty="0" err="1" smtClean="0"/>
                <a:t>collection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into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central</a:t>
              </a:r>
              <a:r>
                <a:rPr lang="it-IT" sz="1200" dirty="0" smtClean="0"/>
                <a:t> database </a:t>
              </a:r>
            </a:p>
            <a:p>
              <a:pPr algn="ctr"/>
              <a:r>
                <a:rPr lang="it-IT" sz="1200" dirty="0" smtClean="0"/>
                <a:t>  (n= 137)</a:t>
              </a:r>
              <a:endParaRPr lang="en-US" sz="1200" dirty="0"/>
            </a:p>
          </p:txBody>
        </p:sp>
        <p:sp>
          <p:nvSpPr>
            <p:cNvPr id="5" name="CasellaDiTesto 4"/>
            <p:cNvSpPr txBox="1"/>
            <p:nvPr/>
          </p:nvSpPr>
          <p:spPr>
            <a:xfrm>
              <a:off x="4423037" y="1057951"/>
              <a:ext cx="263210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smtClean="0"/>
                <a:t>Total </a:t>
              </a:r>
              <a:r>
                <a:rPr lang="it-IT" sz="1200" dirty="0" err="1" smtClean="0"/>
                <a:t>registered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patients</a:t>
              </a:r>
              <a:r>
                <a:rPr lang="it-IT" sz="1200" dirty="0" smtClean="0"/>
                <a:t> </a:t>
              </a:r>
            </a:p>
            <a:p>
              <a:pPr algn="ctr"/>
              <a:r>
                <a:rPr lang="en-US" sz="1200" dirty="0" smtClean="0"/>
                <a:t>July 2015 to </a:t>
              </a:r>
              <a:r>
                <a:rPr lang="en-US" sz="1200" dirty="0"/>
                <a:t>December </a:t>
              </a:r>
              <a:r>
                <a:rPr lang="en-US" sz="1200" dirty="0" smtClean="0"/>
                <a:t>2016</a:t>
              </a:r>
            </a:p>
            <a:p>
              <a:pPr algn="ctr"/>
              <a:r>
                <a:rPr lang="it-IT" sz="1200" dirty="0"/>
                <a:t>(n= </a:t>
              </a:r>
              <a:r>
                <a:rPr lang="it-IT" sz="1200" dirty="0" smtClean="0"/>
                <a:t>140)</a:t>
              </a:r>
              <a:endParaRPr lang="it-IT" sz="1200" dirty="0"/>
            </a:p>
          </p:txBody>
        </p:sp>
        <p:sp>
          <p:nvSpPr>
            <p:cNvPr id="12" name="Rettangolo 11"/>
            <p:cNvSpPr/>
            <p:nvPr/>
          </p:nvSpPr>
          <p:spPr>
            <a:xfrm>
              <a:off x="4767716" y="1057951"/>
              <a:ext cx="1980000" cy="659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7635018" y="2418634"/>
              <a:ext cx="375302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 err="1"/>
                <a:t>Excluded</a:t>
              </a:r>
              <a:r>
                <a:rPr lang="it-IT" sz="1200" dirty="0"/>
                <a:t> (n= 4</a:t>
              </a:r>
              <a:r>
                <a:rPr lang="it-IT" sz="1200" dirty="0" smtClean="0"/>
                <a:t>)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200" dirty="0" err="1" smtClean="0"/>
                <a:t>Patients</a:t>
              </a:r>
              <a:r>
                <a:rPr lang="it-IT" sz="1200" dirty="0" smtClean="0"/>
                <a:t>  with </a:t>
              </a:r>
              <a:r>
                <a:rPr lang="it-IT" sz="1200" dirty="0" err="1" smtClean="0"/>
                <a:t>progression</a:t>
              </a:r>
              <a:r>
                <a:rPr lang="it-IT" sz="1200" dirty="0" smtClean="0"/>
                <a:t> or </a:t>
              </a:r>
              <a:r>
                <a:rPr lang="it-IT" sz="1200" dirty="0" err="1" smtClean="0"/>
                <a:t>death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not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evaluable</a:t>
              </a:r>
              <a:r>
                <a:rPr lang="it-IT" sz="1200" dirty="0" smtClean="0"/>
                <a:t> (n=1)</a:t>
              </a:r>
              <a:endParaRPr lang="it-IT" sz="1200" dirty="0"/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200" dirty="0" err="1" smtClean="0"/>
                <a:t>Patients</a:t>
              </a:r>
              <a:r>
                <a:rPr lang="it-IT" sz="1200" dirty="0" smtClean="0"/>
                <a:t> with </a:t>
              </a:r>
              <a:r>
                <a:rPr lang="it-IT" sz="1200" dirty="0" err="1" smtClean="0"/>
                <a:t>missing</a:t>
              </a:r>
              <a:r>
                <a:rPr lang="it-IT" sz="1200" dirty="0" smtClean="0"/>
                <a:t> &gt;3 </a:t>
              </a:r>
              <a:r>
                <a:rPr lang="it-IT" sz="1200" dirty="0" err="1" smtClean="0"/>
                <a:t>covariate</a:t>
              </a:r>
              <a:r>
                <a:rPr lang="it-IT" sz="1200" dirty="0" smtClean="0"/>
                <a:t> data  (n= 3)</a:t>
              </a:r>
            </a:p>
          </p:txBody>
        </p:sp>
        <p:sp>
          <p:nvSpPr>
            <p:cNvPr id="14" name="Rettangolo 13"/>
            <p:cNvSpPr/>
            <p:nvPr/>
          </p:nvSpPr>
          <p:spPr>
            <a:xfrm>
              <a:off x="7635018" y="2343805"/>
              <a:ext cx="3753029" cy="84051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7635018" y="945042"/>
              <a:ext cx="3659015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 err="1" smtClean="0"/>
                <a:t>Excluded</a:t>
              </a:r>
              <a:r>
                <a:rPr lang="it-IT" sz="1200" dirty="0" smtClean="0"/>
                <a:t> (n=3 )</a:t>
              </a:r>
              <a:endParaRPr lang="it-IT" sz="1200" dirty="0"/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200" dirty="0" err="1" smtClean="0"/>
                <a:t>Mis-diagnosis</a:t>
              </a:r>
              <a:r>
                <a:rPr lang="it-IT" sz="1200" dirty="0" smtClean="0"/>
                <a:t> </a:t>
              </a:r>
              <a:r>
                <a:rPr lang="it-IT" sz="1200" dirty="0"/>
                <a:t>of </a:t>
              </a:r>
              <a:r>
                <a:rPr lang="it-IT" sz="1200" dirty="0" err="1" smtClean="0"/>
                <a:t>cHL</a:t>
              </a:r>
              <a:r>
                <a:rPr lang="it-IT" sz="1200" dirty="0" smtClean="0"/>
                <a:t> (n=1)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200" dirty="0" err="1" smtClean="0"/>
                <a:t>Intercurrent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death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before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exposure</a:t>
              </a:r>
              <a:r>
                <a:rPr lang="it-IT" sz="1200" dirty="0" smtClean="0"/>
                <a:t> </a:t>
              </a:r>
              <a:r>
                <a:rPr lang="it-IT" sz="1200" dirty="0"/>
                <a:t>to </a:t>
              </a:r>
              <a:r>
                <a:rPr lang="it-IT" sz="1200" dirty="0" smtClean="0"/>
                <a:t>anti-PD1 (n=1)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200" dirty="0" err="1" smtClean="0"/>
                <a:t>Not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received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exposure</a:t>
              </a:r>
              <a:r>
                <a:rPr lang="it-IT" sz="1200" dirty="0" smtClean="0"/>
                <a:t> to anti-PD1 (n= 1)</a:t>
              </a:r>
            </a:p>
          </p:txBody>
        </p:sp>
        <p:sp>
          <p:nvSpPr>
            <p:cNvPr id="15" name="Rettangolo 14"/>
            <p:cNvSpPr/>
            <p:nvPr/>
          </p:nvSpPr>
          <p:spPr>
            <a:xfrm>
              <a:off x="7635018" y="861291"/>
              <a:ext cx="3659015" cy="10525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ttangolo 15"/>
            <p:cNvSpPr/>
            <p:nvPr/>
          </p:nvSpPr>
          <p:spPr>
            <a:xfrm>
              <a:off x="4529496" y="2444257"/>
              <a:ext cx="2419187" cy="6463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828676" y="845200"/>
              <a:ext cx="2957976" cy="24929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i="1" dirty="0" err="1" smtClean="0"/>
                <a:t>Northern</a:t>
              </a:r>
              <a:r>
                <a:rPr lang="it-IT" sz="1200" b="1" i="1" dirty="0" smtClean="0"/>
                <a:t> </a:t>
              </a:r>
              <a:r>
                <a:rPr lang="it-IT" sz="1200" b="1" i="1" dirty="0" err="1" smtClean="0"/>
                <a:t>Italy</a:t>
              </a:r>
              <a:r>
                <a:rPr lang="it-IT" sz="1200" b="1" i="1" dirty="0" smtClean="0"/>
                <a:t> </a:t>
              </a:r>
              <a:r>
                <a:rPr lang="it-IT" sz="1200" b="1" i="1" dirty="0" err="1" smtClean="0"/>
                <a:t>Consortium</a:t>
              </a:r>
              <a:r>
                <a:rPr lang="it-IT" sz="1200" b="1" i="1" dirty="0" smtClean="0"/>
                <a:t> </a:t>
              </a:r>
              <a:r>
                <a:rPr lang="it-IT" sz="1200" dirty="0" smtClean="0"/>
                <a:t>(n</a:t>
              </a:r>
              <a:r>
                <a:rPr lang="it-IT" sz="1200" dirty="0"/>
                <a:t>= </a:t>
              </a:r>
              <a:r>
                <a:rPr lang="it-IT" sz="1200" dirty="0" smtClean="0"/>
                <a:t>50 </a:t>
              </a:r>
              <a:r>
                <a:rPr lang="it-IT" sz="1200" dirty="0" err="1" smtClean="0"/>
                <a:t>pts</a:t>
              </a:r>
              <a:r>
                <a:rPr lang="it-IT" sz="1200" dirty="0" smtClean="0"/>
                <a:t>.) 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200" dirty="0" err="1" smtClean="0"/>
                <a:t>Study</a:t>
              </a:r>
              <a:r>
                <a:rPr lang="it-IT" sz="1200" dirty="0" smtClean="0"/>
                <a:t> Coordinator: A. </a:t>
              </a:r>
              <a:r>
                <a:rPr lang="it-IT" sz="1200" dirty="0"/>
                <a:t>Santoro  </a:t>
              </a:r>
              <a:r>
                <a:rPr lang="it-IT" sz="1200" dirty="0" smtClean="0"/>
                <a:t>  </a:t>
              </a:r>
              <a:r>
                <a:rPr lang="it-IT" sz="1200" dirty="0" err="1" smtClean="0"/>
                <a:t>Humanitas</a:t>
              </a:r>
              <a:r>
                <a:rPr lang="it-IT" sz="1200" dirty="0" smtClean="0"/>
                <a:t> </a:t>
              </a:r>
              <a:r>
                <a:rPr lang="it-IT" sz="1200" dirty="0" err="1"/>
                <a:t>University</a:t>
              </a:r>
              <a:r>
                <a:rPr lang="it-IT" sz="1200" dirty="0"/>
                <a:t>; IRCCS </a:t>
              </a:r>
              <a:r>
                <a:rPr lang="it-IT" sz="1200" dirty="0" err="1"/>
                <a:t>Humanitas</a:t>
              </a:r>
              <a:r>
                <a:rPr lang="it-IT" sz="1200" dirty="0"/>
                <a:t> </a:t>
              </a:r>
              <a:r>
                <a:rPr lang="it-IT" sz="1200" dirty="0" err="1"/>
                <a:t>Research</a:t>
              </a:r>
              <a:r>
                <a:rPr lang="it-IT" sz="1200" dirty="0"/>
                <a:t> Hospital </a:t>
              </a:r>
              <a:r>
                <a:rPr lang="it-IT" sz="1200" dirty="0" smtClean="0"/>
                <a:t>, Milan  </a:t>
              </a:r>
            </a:p>
            <a:p>
              <a:r>
                <a:rPr lang="it-IT" sz="1200" b="1" i="1" dirty="0" smtClean="0"/>
                <a:t>Central </a:t>
              </a:r>
              <a:r>
                <a:rPr lang="it-IT" sz="1200" b="1" i="1" dirty="0" err="1" smtClean="0"/>
                <a:t>Italy</a:t>
              </a:r>
              <a:r>
                <a:rPr lang="it-IT" sz="1200" b="1" i="1" dirty="0" smtClean="0"/>
                <a:t> </a:t>
              </a:r>
              <a:r>
                <a:rPr lang="it-IT" sz="1200" b="1" i="1" dirty="0" err="1" smtClean="0"/>
                <a:t>Consortium</a:t>
              </a:r>
              <a:r>
                <a:rPr lang="it-IT" sz="1200" b="1" i="1" dirty="0" smtClean="0"/>
                <a:t> </a:t>
              </a:r>
              <a:r>
                <a:rPr lang="it-IT" sz="1200" dirty="0"/>
                <a:t>(n= </a:t>
              </a:r>
              <a:r>
                <a:rPr lang="it-IT" sz="1200" dirty="0" smtClean="0"/>
                <a:t>47 </a:t>
              </a:r>
              <a:r>
                <a:rPr lang="it-IT" sz="1200" dirty="0" err="1" smtClean="0"/>
                <a:t>pts</a:t>
              </a:r>
              <a:r>
                <a:rPr lang="it-IT" sz="1200" dirty="0" smtClean="0"/>
                <a:t>.)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200" dirty="0" err="1" smtClean="0"/>
                <a:t>Study</a:t>
              </a:r>
              <a:r>
                <a:rPr lang="it-IT" sz="1200" dirty="0" smtClean="0"/>
                <a:t> Coordinator: PL. </a:t>
              </a:r>
              <a:r>
                <a:rPr lang="it-IT" sz="1200" dirty="0" err="1" smtClean="0"/>
                <a:t>Zinzani</a:t>
              </a:r>
              <a:r>
                <a:rPr lang="it-IT" sz="1200" dirty="0"/>
                <a:t>  </a:t>
              </a:r>
              <a:r>
                <a:rPr lang="it-IT" sz="1200" dirty="0" smtClean="0"/>
                <a:t>                      IRCCS </a:t>
              </a:r>
              <a:r>
                <a:rPr lang="it-IT" sz="1200" dirty="0"/>
                <a:t>Azienda Ospedaliero-Universitaria di </a:t>
              </a:r>
              <a:r>
                <a:rPr lang="it-IT" sz="1200" dirty="0" smtClean="0"/>
                <a:t>Bologna</a:t>
              </a:r>
            </a:p>
            <a:p>
              <a:r>
                <a:rPr lang="it-IT" sz="1200" b="1" i="1" dirty="0" smtClean="0"/>
                <a:t>Southern </a:t>
              </a:r>
              <a:r>
                <a:rPr lang="it-IT" sz="1200" b="1" i="1" dirty="0" err="1" smtClean="0"/>
                <a:t>Italy</a:t>
              </a:r>
              <a:r>
                <a:rPr lang="it-IT" sz="1200" b="1" i="1" dirty="0" smtClean="0"/>
                <a:t> </a:t>
              </a:r>
              <a:r>
                <a:rPr lang="it-IT" sz="1200" b="1" i="1" dirty="0" err="1" smtClean="0"/>
                <a:t>Consortium</a:t>
              </a:r>
              <a:r>
                <a:rPr lang="it-IT" sz="1200" b="1" i="1" dirty="0" smtClean="0"/>
                <a:t> </a:t>
              </a:r>
              <a:r>
                <a:rPr lang="it-IT" sz="1200" dirty="0"/>
                <a:t>(n= </a:t>
              </a:r>
              <a:r>
                <a:rPr lang="it-IT" sz="1200" dirty="0" smtClean="0"/>
                <a:t>43 </a:t>
              </a:r>
              <a:r>
                <a:rPr lang="it-IT" sz="1200" dirty="0" err="1" smtClean="0"/>
                <a:t>pts</a:t>
              </a:r>
              <a:r>
                <a:rPr lang="it-IT" sz="1200" dirty="0" smtClean="0"/>
                <a:t>.)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it-IT" sz="1200" dirty="0" err="1" smtClean="0"/>
                <a:t>Study</a:t>
              </a:r>
              <a:r>
                <a:rPr lang="it-IT" sz="1200" dirty="0" smtClean="0"/>
                <a:t> Coordinator: A. Pinto                          </a:t>
              </a:r>
              <a:r>
                <a:rPr lang="it-IT" sz="1200" dirty="0"/>
                <a:t>Istituto Nazionale Tumori, Fondazione 'G. </a:t>
              </a:r>
              <a:r>
                <a:rPr lang="it-IT" sz="1200" dirty="0" err="1"/>
                <a:t>Pascale</a:t>
              </a:r>
              <a:r>
                <a:rPr lang="it-IT" sz="1200" dirty="0"/>
                <a:t>', IRCCS, </a:t>
              </a:r>
              <a:r>
                <a:rPr lang="it-IT" sz="1200" dirty="0" err="1" smtClean="0"/>
                <a:t>Naples</a:t>
              </a:r>
              <a:endParaRPr lang="it-IT" sz="1200" dirty="0" smtClean="0"/>
            </a:p>
            <a:p>
              <a:pPr marL="171450" indent="-171450">
                <a:buFont typeface="Arial" panose="020B0604020202020204" pitchFamily="34" charset="0"/>
                <a:buChar char="•"/>
              </a:pPr>
              <a:endParaRPr lang="en-US" sz="1200" dirty="0"/>
            </a:p>
          </p:txBody>
        </p:sp>
        <p:sp>
          <p:nvSpPr>
            <p:cNvPr id="17" name="Rettangolo 16"/>
            <p:cNvSpPr/>
            <p:nvPr/>
          </p:nvSpPr>
          <p:spPr>
            <a:xfrm>
              <a:off x="828676" y="668752"/>
              <a:ext cx="3064710" cy="26187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4437283" y="3728680"/>
              <a:ext cx="259436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 smtClean="0"/>
                <a:t>Patients</a:t>
              </a:r>
              <a:r>
                <a:rPr lang="it-IT" sz="1200" dirty="0" smtClean="0"/>
                <a:t> with full set of data and </a:t>
              </a:r>
              <a:r>
                <a:rPr lang="it-IT" sz="1200" dirty="0" err="1" smtClean="0"/>
                <a:t>updated</a:t>
              </a:r>
              <a:r>
                <a:rPr lang="it-IT" sz="1200" dirty="0" smtClean="0"/>
                <a:t> </a:t>
              </a:r>
              <a:r>
                <a:rPr lang="it-IT" sz="1200" dirty="0" err="1" smtClean="0"/>
                <a:t>follow</a:t>
              </a:r>
              <a:r>
                <a:rPr lang="it-IT" sz="1200" dirty="0"/>
                <a:t> </a:t>
              </a:r>
              <a:r>
                <a:rPr lang="it-IT" sz="1200" dirty="0" smtClean="0"/>
                <a:t>up to </a:t>
              </a:r>
              <a:r>
                <a:rPr lang="it-IT" sz="1200" dirty="0" err="1" smtClean="0"/>
                <a:t>December</a:t>
              </a:r>
              <a:r>
                <a:rPr lang="it-IT" sz="1200" dirty="0" smtClean="0"/>
                <a:t> 2018 (database </a:t>
              </a:r>
              <a:r>
                <a:rPr lang="it-IT" sz="1200" dirty="0" err="1" smtClean="0"/>
                <a:t>lock</a:t>
              </a:r>
              <a:r>
                <a:rPr lang="it-IT" sz="1200" dirty="0" smtClean="0"/>
                <a:t>)</a:t>
              </a:r>
            </a:p>
            <a:p>
              <a:pPr algn="ctr"/>
              <a:r>
                <a:rPr lang="it-IT" sz="1200" dirty="0" smtClean="0"/>
                <a:t>  (n= 133)</a:t>
              </a:r>
              <a:endParaRPr lang="en-US" sz="1200" dirty="0"/>
            </a:p>
          </p:txBody>
        </p:sp>
        <p:sp>
          <p:nvSpPr>
            <p:cNvPr id="19" name="Rettangolo 18"/>
            <p:cNvSpPr/>
            <p:nvPr/>
          </p:nvSpPr>
          <p:spPr>
            <a:xfrm>
              <a:off x="4465773" y="3718851"/>
              <a:ext cx="2575123" cy="8408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9" name="Connettore 2 28"/>
            <p:cNvCxnSpPr/>
            <p:nvPr/>
          </p:nvCxnSpPr>
          <p:spPr>
            <a:xfrm>
              <a:off x="5739089" y="1722058"/>
              <a:ext cx="0" cy="684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2 30"/>
            <p:cNvCxnSpPr/>
            <p:nvPr/>
          </p:nvCxnSpPr>
          <p:spPr>
            <a:xfrm>
              <a:off x="5739089" y="3110546"/>
              <a:ext cx="0" cy="576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ttore 2 31"/>
            <p:cNvCxnSpPr/>
            <p:nvPr/>
          </p:nvCxnSpPr>
          <p:spPr>
            <a:xfrm rot="16200000">
              <a:off x="7289775" y="2455451"/>
              <a:ext cx="0" cy="648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ttore 2 32"/>
            <p:cNvCxnSpPr/>
            <p:nvPr/>
          </p:nvCxnSpPr>
          <p:spPr>
            <a:xfrm rot="16200000">
              <a:off x="7203955" y="973561"/>
              <a:ext cx="0" cy="828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2 33"/>
            <p:cNvCxnSpPr/>
            <p:nvPr/>
          </p:nvCxnSpPr>
          <p:spPr>
            <a:xfrm rot="16200000">
              <a:off x="4307385" y="973562"/>
              <a:ext cx="0" cy="828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Rettangolo 19">
            <a:extLst>
              <a:ext uri="{FF2B5EF4-FFF2-40B4-BE49-F238E27FC236}">
                <a16:creationId xmlns:a16="http://schemas.microsoft.com/office/drawing/2014/main" xmlns="" id="{85BA17D6-F1FA-CE46-889C-CD8B9156BF1E}"/>
              </a:ext>
            </a:extLst>
          </p:cNvPr>
          <p:cNvSpPr/>
          <p:nvPr/>
        </p:nvSpPr>
        <p:spPr>
          <a:xfrm>
            <a:off x="2362771" y="6330721"/>
            <a:ext cx="916820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udy design, included and excluded patient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9483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5093" y="290397"/>
            <a:ext cx="10505615" cy="59094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ttangolo 1"/>
          <p:cNvSpPr/>
          <p:nvPr/>
        </p:nvSpPr>
        <p:spPr>
          <a:xfrm>
            <a:off x="1289610" y="6304971"/>
            <a:ext cx="973658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Body Mas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dex (BMI) an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otentially unfavorable disease-related baseline features</a:t>
            </a:r>
          </a:p>
        </p:txBody>
      </p:sp>
    </p:spTree>
    <p:extLst>
      <p:ext uri="{BB962C8B-B14F-4D97-AF65-F5344CB8AC3E}">
        <p14:creationId xmlns:p14="http://schemas.microsoft.com/office/powerpoint/2010/main" val="1918487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AutoShape 2" descr="https://mail.istitutotumori.na.it/owa/service.svc/s/GetFileAttachment?id=AAMkADU4NGUzZGQ5LTI5MTUtNGE4NC1hOGJkLTRiMjAwMzY0YmQyOQBGAAAAAACJwKMHH%2FqeSKmeJOOtZ3aLBwDO0UMxDtzbSrTmhbBNGo3vAAAAAAEMAADO0UMxDtzbSrTmhbBNGo3vAAIgi5C%2BAAABEgAQAHRQXmuhxbJLnohuQdmO9X4%3D&amp;X-OWA-CANARY=tq_QoXUTW0eEnsA2fgfNMVAK6YocN9kIj82X33SQs9AC0U49gui-DmtRg4BO0v0N4P-2j_Tb7BI.&amp;isImagePreview=True"/>
          <p:cNvSpPr>
            <a:spLocks noChangeAspect="1" noChangeArrowheads="1"/>
          </p:cNvSpPr>
          <p:nvPr/>
        </p:nvSpPr>
        <p:spPr bwMode="auto">
          <a:xfrm>
            <a:off x="5909809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094"/>
          <a:stretch/>
        </p:blipFill>
        <p:spPr bwMode="auto">
          <a:xfrm>
            <a:off x="565150" y="549472"/>
            <a:ext cx="10994118" cy="4700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ttangolo 2"/>
          <p:cNvSpPr/>
          <p:nvPr/>
        </p:nvSpPr>
        <p:spPr>
          <a:xfrm>
            <a:off x="990147" y="5989589"/>
            <a:ext cx="101441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Body Mass Index (BMI) and types and number of previous therapi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BV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entuxima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do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652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xmlns="" id="{5A840B1C-8168-FC48-8776-4517B9D7457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37" b="9365"/>
          <a:stretch/>
        </p:blipFill>
        <p:spPr bwMode="auto">
          <a:xfrm>
            <a:off x="3167516" y="825148"/>
            <a:ext cx="4768169" cy="55399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Rettangolo 26">
            <a:extLst>
              <a:ext uri="{FF2B5EF4-FFF2-40B4-BE49-F238E27FC236}">
                <a16:creationId xmlns:a16="http://schemas.microsoft.com/office/drawing/2014/main" xmlns="" id="{1828BA63-255D-4041-BEC6-CCA2C100BAE3}"/>
              </a:ext>
            </a:extLst>
          </p:cNvPr>
          <p:cNvSpPr/>
          <p:nvPr/>
        </p:nvSpPr>
        <p:spPr>
          <a:xfrm>
            <a:off x="6898512" y="523754"/>
            <a:ext cx="51854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est plot of Cox univariate analysis for progression-free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rvival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cording to several variables.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CT,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utologous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em cell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plant; </a:t>
            </a:r>
            <a:r>
              <a:rPr lang="en-US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o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SCT,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ogeneic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em cell transplant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plant. 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2">
            <a:extLst>
              <a:ext uri="{FF2B5EF4-FFF2-40B4-BE49-F238E27FC236}">
                <a16:creationId xmlns:a16="http://schemas.microsoft.com/office/drawing/2014/main" xmlns="" id="{D40BF696-BCC0-7D4C-A750-4100687AE7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85156" y="4574531"/>
            <a:ext cx="12607604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it-IT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rPr>
              <a:t/>
            </a:r>
            <a:br>
              <a:rPr kumimoji="0" lang="it-IT" altLang="it-IT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</a:rPr>
            </a:br>
            <a:endParaRPr kumimoji="0" lang="it-IT" altLang="it-IT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it-IT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" pitchFamily="2" charset="0"/>
              </a:rPr>
              <a:t/>
            </a:r>
            <a:br>
              <a:rPr kumimoji="0" lang="it-IT" altLang="it-IT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" pitchFamily="2" charset="0"/>
              </a:rPr>
            </a:br>
            <a:endParaRPr kumimoji="0" lang="it-IT" altLang="it-IT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9" name="Tabella 8">
            <a:extLst>
              <a:ext uri="{FF2B5EF4-FFF2-40B4-BE49-F238E27FC236}">
                <a16:creationId xmlns:a16="http://schemas.microsoft.com/office/drawing/2014/main" xmlns="" id="{FC4183D8-49A0-2847-83BC-2340EA6369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1187414"/>
              </p:ext>
            </p:extLst>
          </p:nvPr>
        </p:nvGraphicFramePr>
        <p:xfrm>
          <a:off x="439838" y="523754"/>
          <a:ext cx="3958542" cy="52313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21397">
                  <a:extLst>
                    <a:ext uri="{9D8B030D-6E8A-4147-A177-3AD203B41FA5}">
                      <a16:colId xmlns:a16="http://schemas.microsoft.com/office/drawing/2014/main" xmlns="" val="4048941753"/>
                    </a:ext>
                  </a:extLst>
                </a:gridCol>
                <a:gridCol w="537613">
                  <a:extLst>
                    <a:ext uri="{9D8B030D-6E8A-4147-A177-3AD203B41FA5}">
                      <a16:colId xmlns:a16="http://schemas.microsoft.com/office/drawing/2014/main" xmlns="" val="14957610"/>
                    </a:ext>
                  </a:extLst>
                </a:gridCol>
                <a:gridCol w="434661">
                  <a:extLst>
                    <a:ext uri="{9D8B030D-6E8A-4147-A177-3AD203B41FA5}">
                      <a16:colId xmlns:a16="http://schemas.microsoft.com/office/drawing/2014/main" xmlns="" val="1672033238"/>
                    </a:ext>
                  </a:extLst>
                </a:gridCol>
                <a:gridCol w="462987">
                  <a:extLst>
                    <a:ext uri="{9D8B030D-6E8A-4147-A177-3AD203B41FA5}">
                      <a16:colId xmlns:a16="http://schemas.microsoft.com/office/drawing/2014/main" xmlns="" val="1164677729"/>
                    </a:ext>
                  </a:extLst>
                </a:gridCol>
                <a:gridCol w="601884">
                  <a:extLst>
                    <a:ext uri="{9D8B030D-6E8A-4147-A177-3AD203B41FA5}">
                      <a16:colId xmlns:a16="http://schemas.microsoft.com/office/drawing/2014/main" xmlns="" val="394359371"/>
                    </a:ext>
                  </a:extLst>
                </a:gridCol>
              </a:tblGrid>
              <a:tr h="202192">
                <a:tc>
                  <a:txBody>
                    <a:bodyPr/>
                    <a:lstStyle/>
                    <a:p>
                      <a:pPr algn="ctr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s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it-IT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.R.</a:t>
                      </a:r>
                      <a:endParaRPr lang="it-IT" sz="11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gridSpan="2">
                  <a:txBody>
                    <a:bodyPr/>
                    <a:lstStyle/>
                    <a:p>
                      <a:pPr algn="r"/>
                      <a:r>
                        <a:rPr lang="it-IT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.I.</a:t>
                      </a:r>
                      <a:endParaRPr lang="it-IT" sz="11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it-IT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it-IT" sz="11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58264081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logy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9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0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87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98182933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S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608174105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ious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llo-SCT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3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2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7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77607105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o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20781392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ious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SCT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4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4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1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25460644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o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904969577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ious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V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7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4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91278581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 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169809715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</a:t>
                      </a:r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ptoms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9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9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47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35024394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o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686850171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logy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0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1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88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45151640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S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63649915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8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19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13731778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-II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462382200"/>
                  </a:ext>
                </a:extLst>
              </a:tr>
              <a:tr h="245719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formans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tatus (ECOG)</a:t>
                      </a: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9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5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55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34943581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logy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4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3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01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20867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S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19227762"/>
                  </a:ext>
                </a:extLst>
              </a:tr>
              <a:tr h="245719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formans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tatus (ECOG)</a:t>
                      </a: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0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17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7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47681132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lky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3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38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41081558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o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62486407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° of </a:t>
                      </a:r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s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2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37899082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1" u="sng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lt;4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282051550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54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8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6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98859214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-II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33134470"/>
                  </a:ext>
                </a:extLst>
              </a:tr>
              <a:tr h="245719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formans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tatus (ECOG)</a:t>
                      </a: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0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3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73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040809863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l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 </a:t>
                      </a:r>
                      <a:r>
                        <a:rPr lang="it-IT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olvement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8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78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/>
                      <a:endParaRPr lang="it-IT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99425978"/>
                  </a:ext>
                </a:extLst>
              </a:tr>
              <a:tr h="126370">
                <a:tc>
                  <a:txBody>
                    <a:bodyPr/>
                    <a:lstStyle/>
                    <a:p>
                      <a:pPr algn="r"/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</a:t>
                      </a:r>
                      <a:r>
                        <a:rPr lang="it-IT" sz="11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.</a:t>
                      </a:r>
                      <a:r>
                        <a:rPr lang="it-IT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o</a:t>
                      </a:r>
                      <a:endParaRPr lang="it-IT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4572" marR="24572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126541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378562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16</TotalTime>
  <Words>430</Words>
  <Application>Microsoft Office PowerPoint</Application>
  <PresentationFormat>Personalizzato</PresentationFormat>
  <Paragraphs>181</Paragraphs>
  <Slides>4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5" baseType="lpstr"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crosoft Office User</dc:creator>
  <cp:lastModifiedBy>User</cp:lastModifiedBy>
  <cp:revision>76</cp:revision>
  <cp:lastPrinted>2021-06-25T15:34:35Z</cp:lastPrinted>
  <dcterms:created xsi:type="dcterms:W3CDTF">2021-06-06T16:45:28Z</dcterms:created>
  <dcterms:modified xsi:type="dcterms:W3CDTF">2021-10-17T12:16:14Z</dcterms:modified>
</cp:coreProperties>
</file>